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56" r:id="rId5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5AB5DA-58BC-A22E-AF68-D2183C6C4E3B}" v="18" dt="2025-12-03T14:39:49.5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48"/>
  </p:normalViewPr>
  <p:slideViewPr>
    <p:cSldViewPr snapToGrid="0">
      <p:cViewPr>
        <p:scale>
          <a:sx n="83" d="100"/>
          <a:sy n="83" d="100"/>
        </p:scale>
        <p:origin x="2168" y="-1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chel Edwards" userId="S::rachel.edwards@omniose.com::9526a979-b0ff-461c-b936-05f0a0158e0f" providerId="AD" clId="Web-{655AB5DA-58BC-A22E-AF68-D2183C6C4E3B}"/>
    <pc:docChg chg="modSld">
      <pc:chgData name="Rachel Edwards" userId="S::rachel.edwards@omniose.com::9526a979-b0ff-461c-b936-05f0a0158e0f" providerId="AD" clId="Web-{655AB5DA-58BC-A22E-AF68-D2183C6C4E3B}" dt="2025-12-03T14:39:47.883" v="7" actId="20577"/>
      <pc:docMkLst>
        <pc:docMk/>
      </pc:docMkLst>
      <pc:sldChg chg="modSp">
        <pc:chgData name="Rachel Edwards" userId="S::rachel.edwards@omniose.com::9526a979-b0ff-461c-b936-05f0a0158e0f" providerId="AD" clId="Web-{655AB5DA-58BC-A22E-AF68-D2183C6C4E3B}" dt="2025-12-03T14:39:47.883" v="7" actId="20577"/>
        <pc:sldMkLst>
          <pc:docMk/>
          <pc:sldMk cId="989592059" sldId="256"/>
        </pc:sldMkLst>
        <pc:spChg chg="mod">
          <ac:chgData name="Rachel Edwards" userId="S::rachel.edwards@omniose.com::9526a979-b0ff-461c-b936-05f0a0158e0f" providerId="AD" clId="Web-{655AB5DA-58BC-A22E-AF68-D2183C6C4E3B}" dt="2025-12-03T14:39:47.883" v="7" actId="20577"/>
          <ac:spMkLst>
            <pc:docMk/>
            <pc:sldMk cId="989592059" sldId="256"/>
            <ac:spMk id="12" creationId="{7918C372-02A7-200A-BF18-B33C84E8178B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omniosestl-my.sharepoint.com/personal/rachel_edwards_omniose_com/Documents/Desktop/Omniose/Manuscripts/Files%20for%20compiling%20tables%20and%20figures/Figure%202.%20Scatter%20plo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omniosestl-my.sharepoint.com/personal/rachel_edwards_omniose_com/Documents/Desktop/Omniose/Manuscripts/Files%20for%20compiling%20tables%20and%20figures/Figure%202.%20Scatter%20plo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omniosestl-my.sharepoint.com/personal/rachel_edwards_omniose_com/Documents/Desktop/Omniose/Manuscripts/Files%20for%20compiling%20tables%20and%20figures/Figure%202.%20Scatter%20plo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omniosestl-my.sharepoint.com/personal/rachel_edwards_omniose_com/Documents/Desktop/Omniose/Manuscripts/Files%20for%20compiling%20tables%20and%20figures/Figure%202.%20Scatter%20plot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omniosestl-my.sharepoint.com/personal/rachel_edwards_omniose_com/Documents/Desktop/Omniose/Manuscripts/Files%20for%20compiling%20tables%20and%20figures/Figure%202.%20Scatter%20plot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/>
              <a:t>N2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N28W Data'!$F$13</c:f>
              <c:strCache>
                <c:ptCount val="1"/>
                <c:pt idx="0">
                  <c:v>OD4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  <a:prstDash val="solid"/>
              </a:ln>
              <a:effectLst/>
            </c:spPr>
          </c:marker>
          <c:dPt>
            <c:idx val="0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0D1C-9D43-81AA-A846DAB1EFC6}"/>
              </c:ext>
            </c:extLst>
          </c:dPt>
          <c:dPt>
            <c:idx val="1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0D1C-9D43-81AA-A846DAB1EFC6}"/>
              </c:ext>
            </c:extLst>
          </c:dPt>
          <c:dPt>
            <c:idx val="53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0D1C-9D43-81AA-A846DAB1EFC6}"/>
              </c:ext>
            </c:extLst>
          </c:dPt>
          <c:dPt>
            <c:idx val="55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0D1C-9D43-81AA-A846DAB1EFC6}"/>
              </c:ext>
            </c:extLst>
          </c:dPt>
          <c:dPt>
            <c:idx val="57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0D1C-9D43-81AA-A846DAB1EFC6}"/>
              </c:ext>
            </c:extLst>
          </c:dPt>
          <c:dPt>
            <c:idx val="75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0D1C-9D43-81AA-A846DAB1EFC6}"/>
              </c:ext>
            </c:extLst>
          </c:dPt>
          <c:dPt>
            <c:idx val="79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0D1C-9D43-81AA-A846DAB1EFC6}"/>
              </c:ext>
            </c:extLst>
          </c:dPt>
          <c:dPt>
            <c:idx val="93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0D1C-9D43-81AA-A846DAB1EFC6}"/>
              </c:ext>
            </c:extLst>
          </c:dPt>
          <c:xVal>
            <c:numRef>
              <c:f>'N28W Data'!$E$14:$E$113</c:f>
              <c:numCache>
                <c:formatCode>General</c:formatCod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numCache>
            </c:numRef>
          </c:xVal>
          <c:yVal>
            <c:numRef>
              <c:f>'N28W Data'!$F$14:$F$113</c:f>
              <c:numCache>
                <c:formatCode>0.0000</c:formatCode>
                <c:ptCount val="100"/>
                <c:pt idx="0">
                  <c:v>0.31019999999999998</c:v>
                </c:pt>
                <c:pt idx="1">
                  <c:v>0.28000000000000003</c:v>
                </c:pt>
                <c:pt idx="2">
                  <c:v>0.27350000000000002</c:v>
                </c:pt>
                <c:pt idx="3">
                  <c:v>0.27329999999999999</c:v>
                </c:pt>
                <c:pt idx="4">
                  <c:v>0.2475</c:v>
                </c:pt>
                <c:pt idx="5">
                  <c:v>0.23749999999999999</c:v>
                </c:pt>
                <c:pt idx="6">
                  <c:v>0.2276</c:v>
                </c:pt>
                <c:pt idx="7">
                  <c:v>0.2235</c:v>
                </c:pt>
                <c:pt idx="8">
                  <c:v>0.22</c:v>
                </c:pt>
                <c:pt idx="9">
                  <c:v>0.219</c:v>
                </c:pt>
                <c:pt idx="10">
                  <c:v>0.2185</c:v>
                </c:pt>
                <c:pt idx="11">
                  <c:v>0.21609999999999999</c:v>
                </c:pt>
                <c:pt idx="12">
                  <c:v>0.20860000000000001</c:v>
                </c:pt>
                <c:pt idx="13">
                  <c:v>0.20830000000000001</c:v>
                </c:pt>
                <c:pt idx="14">
                  <c:v>0.2064</c:v>
                </c:pt>
                <c:pt idx="15">
                  <c:v>0.2051</c:v>
                </c:pt>
                <c:pt idx="16">
                  <c:v>0.20180000000000001</c:v>
                </c:pt>
                <c:pt idx="17">
                  <c:v>0.19170000000000001</c:v>
                </c:pt>
                <c:pt idx="18">
                  <c:v>0.1898</c:v>
                </c:pt>
                <c:pt idx="19">
                  <c:v>0.1898</c:v>
                </c:pt>
                <c:pt idx="20">
                  <c:v>0.18970000000000001</c:v>
                </c:pt>
                <c:pt idx="21">
                  <c:v>0.1888</c:v>
                </c:pt>
                <c:pt idx="22">
                  <c:v>0.1857</c:v>
                </c:pt>
                <c:pt idx="23">
                  <c:v>0.1852</c:v>
                </c:pt>
                <c:pt idx="24">
                  <c:v>0.18459999999999999</c:v>
                </c:pt>
                <c:pt idx="25">
                  <c:v>0.18379999999999999</c:v>
                </c:pt>
                <c:pt idx="26">
                  <c:v>0.18360000000000001</c:v>
                </c:pt>
                <c:pt idx="27">
                  <c:v>0.18329999999999999</c:v>
                </c:pt>
                <c:pt idx="28">
                  <c:v>0.18290000000000001</c:v>
                </c:pt>
                <c:pt idx="29">
                  <c:v>0.18210000000000001</c:v>
                </c:pt>
                <c:pt idx="30">
                  <c:v>0.18049999999999999</c:v>
                </c:pt>
                <c:pt idx="31">
                  <c:v>0.17949999999999999</c:v>
                </c:pt>
                <c:pt idx="32">
                  <c:v>0.1792</c:v>
                </c:pt>
                <c:pt idx="33">
                  <c:v>0.1782</c:v>
                </c:pt>
                <c:pt idx="34">
                  <c:v>0.17630000000000001</c:v>
                </c:pt>
                <c:pt idx="35">
                  <c:v>0.17499999999999999</c:v>
                </c:pt>
                <c:pt idx="36">
                  <c:v>0.17460000000000001</c:v>
                </c:pt>
                <c:pt idx="37">
                  <c:v>0.1736</c:v>
                </c:pt>
                <c:pt idx="38">
                  <c:v>0.17219999999999999</c:v>
                </c:pt>
                <c:pt idx="39">
                  <c:v>0.17199999999999999</c:v>
                </c:pt>
                <c:pt idx="40">
                  <c:v>0.17180000000000001</c:v>
                </c:pt>
                <c:pt idx="41">
                  <c:v>0.16980000000000001</c:v>
                </c:pt>
                <c:pt idx="42">
                  <c:v>0.16980000000000001</c:v>
                </c:pt>
                <c:pt idx="43">
                  <c:v>0.16850000000000001</c:v>
                </c:pt>
                <c:pt idx="44">
                  <c:v>0.1671</c:v>
                </c:pt>
                <c:pt idx="45">
                  <c:v>0.16569999999999999</c:v>
                </c:pt>
                <c:pt idx="46">
                  <c:v>0.16370000000000001</c:v>
                </c:pt>
                <c:pt idx="47">
                  <c:v>0.16189999999999999</c:v>
                </c:pt>
                <c:pt idx="48">
                  <c:v>0.15790000000000001</c:v>
                </c:pt>
                <c:pt idx="49">
                  <c:v>0.15190000000000001</c:v>
                </c:pt>
                <c:pt idx="50">
                  <c:v>0.15090000000000001</c:v>
                </c:pt>
                <c:pt idx="51">
                  <c:v>0.14979999999999999</c:v>
                </c:pt>
                <c:pt idx="52">
                  <c:v>0.14810000000000001</c:v>
                </c:pt>
                <c:pt idx="53">
                  <c:v>0.14630000000000001</c:v>
                </c:pt>
                <c:pt idx="54">
                  <c:v>0.14599999999999999</c:v>
                </c:pt>
                <c:pt idx="55">
                  <c:v>0.1457</c:v>
                </c:pt>
                <c:pt idx="56">
                  <c:v>0.14410000000000001</c:v>
                </c:pt>
                <c:pt idx="57">
                  <c:v>0.14199999999999999</c:v>
                </c:pt>
                <c:pt idx="58">
                  <c:v>0.13439999999999999</c:v>
                </c:pt>
                <c:pt idx="59">
                  <c:v>0.13350000000000001</c:v>
                </c:pt>
                <c:pt idx="60">
                  <c:v>0.1326</c:v>
                </c:pt>
                <c:pt idx="61">
                  <c:v>0.13070000000000001</c:v>
                </c:pt>
                <c:pt idx="62">
                  <c:v>0.1244</c:v>
                </c:pt>
                <c:pt idx="63">
                  <c:v>0.12429999999999999</c:v>
                </c:pt>
                <c:pt idx="64">
                  <c:v>0.1222</c:v>
                </c:pt>
                <c:pt idx="65">
                  <c:v>0.11940000000000001</c:v>
                </c:pt>
                <c:pt idx="66">
                  <c:v>0.11749999999999999</c:v>
                </c:pt>
                <c:pt idx="67">
                  <c:v>0.1157</c:v>
                </c:pt>
                <c:pt idx="68">
                  <c:v>0.1139</c:v>
                </c:pt>
                <c:pt idx="69">
                  <c:v>0.113</c:v>
                </c:pt>
                <c:pt idx="70">
                  <c:v>0.11260000000000001</c:v>
                </c:pt>
                <c:pt idx="71">
                  <c:v>0.111</c:v>
                </c:pt>
                <c:pt idx="72">
                  <c:v>0.11</c:v>
                </c:pt>
                <c:pt idx="73">
                  <c:v>0.1099</c:v>
                </c:pt>
                <c:pt idx="74">
                  <c:v>0.1075</c:v>
                </c:pt>
                <c:pt idx="75">
                  <c:v>0.10390000000000001</c:v>
                </c:pt>
                <c:pt idx="76">
                  <c:v>0.10249999999999999</c:v>
                </c:pt>
                <c:pt idx="77">
                  <c:v>0.10249999999999999</c:v>
                </c:pt>
                <c:pt idx="78">
                  <c:v>0.1021</c:v>
                </c:pt>
                <c:pt idx="79">
                  <c:v>0.1003</c:v>
                </c:pt>
                <c:pt idx="80">
                  <c:v>9.9299999999999999E-2</c:v>
                </c:pt>
                <c:pt idx="81">
                  <c:v>9.8400000000000001E-2</c:v>
                </c:pt>
                <c:pt idx="82">
                  <c:v>9.8100000000000007E-2</c:v>
                </c:pt>
                <c:pt idx="83">
                  <c:v>9.7299999999999998E-2</c:v>
                </c:pt>
                <c:pt idx="84">
                  <c:v>9.5200000000000007E-2</c:v>
                </c:pt>
                <c:pt idx="85">
                  <c:v>9.4100000000000003E-2</c:v>
                </c:pt>
                <c:pt idx="86">
                  <c:v>9.3399999999999997E-2</c:v>
                </c:pt>
                <c:pt idx="87">
                  <c:v>9.2799999999999994E-2</c:v>
                </c:pt>
                <c:pt idx="88">
                  <c:v>9.2100000000000001E-2</c:v>
                </c:pt>
                <c:pt idx="89">
                  <c:v>9.1600000000000001E-2</c:v>
                </c:pt>
                <c:pt idx="90">
                  <c:v>8.7300000000000003E-2</c:v>
                </c:pt>
                <c:pt idx="91">
                  <c:v>8.4099999999999994E-2</c:v>
                </c:pt>
                <c:pt idx="92">
                  <c:v>8.3699999999999997E-2</c:v>
                </c:pt>
                <c:pt idx="93">
                  <c:v>8.3000000000000004E-2</c:v>
                </c:pt>
                <c:pt idx="94">
                  <c:v>7.7799999999999994E-2</c:v>
                </c:pt>
                <c:pt idx="95">
                  <c:v>7.67000000000000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0D1C-9D43-81AA-A846DAB1EF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660159"/>
        <c:axId val="396249775"/>
      </c:scatterChart>
      <c:valAx>
        <c:axId val="376660159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Clone Number (sorted high to low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96249775"/>
        <c:crosses val="autoZero"/>
        <c:crossBetween val="midCat"/>
      </c:valAx>
      <c:valAx>
        <c:axId val="396249775"/>
        <c:scaling>
          <c:orientation val="minMax"/>
          <c:max val="0.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OD45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60159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/>
              <a:t>R27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R271 Data'!$G$13</c:f>
              <c:strCache>
                <c:ptCount val="1"/>
                <c:pt idx="0">
                  <c:v>ELISA OD4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  <a:prstDash val="solid"/>
              </a:ln>
              <a:effectLst/>
            </c:spPr>
          </c:marker>
          <c:dPt>
            <c:idx val="0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D48D-684A-B3FC-2EF5E8E8CE62}"/>
              </c:ext>
            </c:extLst>
          </c:dPt>
          <c:dPt>
            <c:idx val="1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D48D-684A-B3FC-2EF5E8E8CE62}"/>
              </c:ext>
            </c:extLst>
          </c:dPt>
          <c:dPt>
            <c:idx val="2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D48D-684A-B3FC-2EF5E8E8CE62}"/>
              </c:ext>
            </c:extLst>
          </c:dPt>
          <c:dPt>
            <c:idx val="4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D48D-684A-B3FC-2EF5E8E8CE62}"/>
              </c:ext>
            </c:extLst>
          </c:dPt>
          <c:dPt>
            <c:idx val="5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D48D-684A-B3FC-2EF5E8E8CE62}"/>
              </c:ext>
            </c:extLst>
          </c:dPt>
          <c:dPt>
            <c:idx val="6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D48D-684A-B3FC-2EF5E8E8CE62}"/>
              </c:ext>
            </c:extLst>
          </c:dPt>
          <c:dPt>
            <c:idx val="8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D48D-684A-B3FC-2EF5E8E8CE62}"/>
              </c:ext>
            </c:extLst>
          </c:dPt>
          <c:dPt>
            <c:idx val="9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D48D-684A-B3FC-2EF5E8E8CE62}"/>
              </c:ext>
            </c:extLst>
          </c:dPt>
          <c:dPt>
            <c:idx val="15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D48D-684A-B3FC-2EF5E8E8CE62}"/>
              </c:ext>
            </c:extLst>
          </c:dPt>
          <c:dPt>
            <c:idx val="41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D48D-684A-B3FC-2EF5E8E8CE62}"/>
              </c:ext>
            </c:extLst>
          </c:dPt>
          <c:dPt>
            <c:idx val="79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D48D-684A-B3FC-2EF5E8E8CE62}"/>
              </c:ext>
            </c:extLst>
          </c:dPt>
          <c:xVal>
            <c:numRef>
              <c:f>'R271 Data'!$F$14:$F$113</c:f>
              <c:numCache>
                <c:formatCode>General</c:formatCod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numCache>
            </c:numRef>
          </c:xVal>
          <c:yVal>
            <c:numRef>
              <c:f>'R271 Data'!$G$14:$G$113</c:f>
              <c:numCache>
                <c:formatCode>0.0000</c:formatCode>
                <c:ptCount val="100"/>
                <c:pt idx="0">
                  <c:v>0.4859</c:v>
                </c:pt>
                <c:pt idx="1">
                  <c:v>0.3296</c:v>
                </c:pt>
                <c:pt idx="2">
                  <c:v>0.2858</c:v>
                </c:pt>
                <c:pt idx="3">
                  <c:v>0.28520000000000001</c:v>
                </c:pt>
                <c:pt idx="4">
                  <c:v>0.26919999999999999</c:v>
                </c:pt>
                <c:pt idx="5">
                  <c:v>0.2666</c:v>
                </c:pt>
                <c:pt idx="6">
                  <c:v>0.26369999999999999</c:v>
                </c:pt>
                <c:pt idx="7">
                  <c:v>0.24660000000000001</c:v>
                </c:pt>
                <c:pt idx="8">
                  <c:v>0.22600000000000001</c:v>
                </c:pt>
                <c:pt idx="9">
                  <c:v>0.21709999999999999</c:v>
                </c:pt>
                <c:pt idx="10">
                  <c:v>0.19620000000000001</c:v>
                </c:pt>
                <c:pt idx="11">
                  <c:v>0.1903</c:v>
                </c:pt>
                <c:pt idx="12">
                  <c:v>0.17599999999999999</c:v>
                </c:pt>
                <c:pt idx="13">
                  <c:v>0.17560000000000001</c:v>
                </c:pt>
                <c:pt idx="14">
                  <c:v>0.17469999999999999</c:v>
                </c:pt>
                <c:pt idx="15">
                  <c:v>0.17369999999999999</c:v>
                </c:pt>
                <c:pt idx="16">
                  <c:v>0.16239999999999999</c:v>
                </c:pt>
                <c:pt idx="17">
                  <c:v>0.157</c:v>
                </c:pt>
                <c:pt idx="18">
                  <c:v>0.1502</c:v>
                </c:pt>
                <c:pt idx="19">
                  <c:v>0.14649999999999999</c:v>
                </c:pt>
                <c:pt idx="20">
                  <c:v>0.1419</c:v>
                </c:pt>
                <c:pt idx="21">
                  <c:v>0.1399</c:v>
                </c:pt>
                <c:pt idx="22">
                  <c:v>0.13900000000000001</c:v>
                </c:pt>
                <c:pt idx="23">
                  <c:v>0.13800000000000001</c:v>
                </c:pt>
                <c:pt idx="24">
                  <c:v>0.1371</c:v>
                </c:pt>
                <c:pt idx="25">
                  <c:v>0.1371</c:v>
                </c:pt>
                <c:pt idx="26">
                  <c:v>0.13639999999999999</c:v>
                </c:pt>
                <c:pt idx="27">
                  <c:v>0.1348</c:v>
                </c:pt>
                <c:pt idx="28">
                  <c:v>0.13450000000000001</c:v>
                </c:pt>
                <c:pt idx="29">
                  <c:v>0.13400000000000001</c:v>
                </c:pt>
                <c:pt idx="30">
                  <c:v>0.1326</c:v>
                </c:pt>
                <c:pt idx="31">
                  <c:v>0.13150000000000001</c:v>
                </c:pt>
                <c:pt idx="32">
                  <c:v>0.12839999999999999</c:v>
                </c:pt>
                <c:pt idx="33">
                  <c:v>0.1258</c:v>
                </c:pt>
                <c:pt idx="34">
                  <c:v>0.1245</c:v>
                </c:pt>
                <c:pt idx="35">
                  <c:v>0.1222</c:v>
                </c:pt>
                <c:pt idx="36">
                  <c:v>0.1221</c:v>
                </c:pt>
                <c:pt idx="37">
                  <c:v>0.12039999999999999</c:v>
                </c:pt>
                <c:pt idx="38">
                  <c:v>0.12039999999999999</c:v>
                </c:pt>
                <c:pt idx="39">
                  <c:v>0.1203</c:v>
                </c:pt>
                <c:pt idx="40">
                  <c:v>0.1203</c:v>
                </c:pt>
                <c:pt idx="41">
                  <c:v>0.11890000000000001</c:v>
                </c:pt>
                <c:pt idx="42">
                  <c:v>0.1186</c:v>
                </c:pt>
                <c:pt idx="43">
                  <c:v>0.11840000000000001</c:v>
                </c:pt>
                <c:pt idx="44">
                  <c:v>0.1173</c:v>
                </c:pt>
                <c:pt idx="45">
                  <c:v>0.1153</c:v>
                </c:pt>
                <c:pt idx="46">
                  <c:v>0.11509999999999999</c:v>
                </c:pt>
                <c:pt idx="47">
                  <c:v>0.115</c:v>
                </c:pt>
                <c:pt idx="48">
                  <c:v>0.1119</c:v>
                </c:pt>
                <c:pt idx="49">
                  <c:v>0.11169999999999999</c:v>
                </c:pt>
                <c:pt idx="50">
                  <c:v>0.1114</c:v>
                </c:pt>
                <c:pt idx="51">
                  <c:v>0.1109</c:v>
                </c:pt>
                <c:pt idx="52">
                  <c:v>0.1105</c:v>
                </c:pt>
                <c:pt idx="53">
                  <c:v>0.1095</c:v>
                </c:pt>
                <c:pt idx="54">
                  <c:v>0.1087</c:v>
                </c:pt>
                <c:pt idx="55">
                  <c:v>0.1085</c:v>
                </c:pt>
                <c:pt idx="56">
                  <c:v>0.108</c:v>
                </c:pt>
                <c:pt idx="57">
                  <c:v>0.1079</c:v>
                </c:pt>
                <c:pt idx="58">
                  <c:v>0.1079</c:v>
                </c:pt>
                <c:pt idx="59">
                  <c:v>0.10780000000000001</c:v>
                </c:pt>
                <c:pt idx="60">
                  <c:v>0.10780000000000001</c:v>
                </c:pt>
                <c:pt idx="61">
                  <c:v>0.1076</c:v>
                </c:pt>
                <c:pt idx="62">
                  <c:v>0.10730000000000001</c:v>
                </c:pt>
                <c:pt idx="63">
                  <c:v>0.10680000000000001</c:v>
                </c:pt>
                <c:pt idx="64">
                  <c:v>0.1066</c:v>
                </c:pt>
                <c:pt idx="65">
                  <c:v>0.10639999999999999</c:v>
                </c:pt>
                <c:pt idx="66">
                  <c:v>0.1061</c:v>
                </c:pt>
                <c:pt idx="67">
                  <c:v>0.1053</c:v>
                </c:pt>
                <c:pt idx="68">
                  <c:v>0.10489999999999999</c:v>
                </c:pt>
                <c:pt idx="69">
                  <c:v>0.10440000000000001</c:v>
                </c:pt>
                <c:pt idx="70">
                  <c:v>0.1041</c:v>
                </c:pt>
                <c:pt idx="71">
                  <c:v>0.1027</c:v>
                </c:pt>
                <c:pt idx="72">
                  <c:v>0.1026</c:v>
                </c:pt>
                <c:pt idx="73">
                  <c:v>0.1023</c:v>
                </c:pt>
                <c:pt idx="74">
                  <c:v>0.1022</c:v>
                </c:pt>
                <c:pt idx="75">
                  <c:v>0.10199999999999999</c:v>
                </c:pt>
                <c:pt idx="76">
                  <c:v>0.1013</c:v>
                </c:pt>
                <c:pt idx="77">
                  <c:v>0.1011</c:v>
                </c:pt>
                <c:pt idx="78">
                  <c:v>0.10050000000000001</c:v>
                </c:pt>
                <c:pt idx="79">
                  <c:v>9.9599999999999994E-2</c:v>
                </c:pt>
                <c:pt idx="80">
                  <c:v>9.9400000000000002E-2</c:v>
                </c:pt>
                <c:pt idx="81">
                  <c:v>9.9299999999999999E-2</c:v>
                </c:pt>
                <c:pt idx="82">
                  <c:v>9.8699999999999996E-2</c:v>
                </c:pt>
                <c:pt idx="83">
                  <c:v>9.8400000000000001E-2</c:v>
                </c:pt>
                <c:pt idx="84">
                  <c:v>9.8100000000000007E-2</c:v>
                </c:pt>
                <c:pt idx="85">
                  <c:v>9.7799999999999998E-2</c:v>
                </c:pt>
                <c:pt idx="86">
                  <c:v>9.7699999999999995E-2</c:v>
                </c:pt>
                <c:pt idx="87">
                  <c:v>9.2499999999999999E-2</c:v>
                </c:pt>
                <c:pt idx="88">
                  <c:v>9.1899999999999996E-2</c:v>
                </c:pt>
                <c:pt idx="89">
                  <c:v>9.06E-2</c:v>
                </c:pt>
                <c:pt idx="90">
                  <c:v>8.9700000000000002E-2</c:v>
                </c:pt>
                <c:pt idx="91">
                  <c:v>8.9599999999999999E-2</c:v>
                </c:pt>
                <c:pt idx="92">
                  <c:v>8.8599999999999998E-2</c:v>
                </c:pt>
                <c:pt idx="93">
                  <c:v>8.4900000000000003E-2</c:v>
                </c:pt>
                <c:pt idx="94">
                  <c:v>6.93E-2</c:v>
                </c:pt>
                <c:pt idx="95">
                  <c:v>4.78000000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3F7-2C46-B6FA-4267C2C3CC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1896080"/>
        <c:axId val="1897210095"/>
      </c:scatterChart>
      <c:valAx>
        <c:axId val="401896080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Clone Number (sorted high to low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97210095"/>
        <c:crosses val="autoZero"/>
        <c:crossBetween val="midCat"/>
      </c:valAx>
      <c:valAx>
        <c:axId val="189721009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OD45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18960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/>
              <a:t>R27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R278 Data'!$G$14</c:f>
              <c:strCache>
                <c:ptCount val="1"/>
                <c:pt idx="0">
                  <c:v>OD4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  <a:prstDash val="solid"/>
              </a:ln>
              <a:effectLst/>
            </c:spPr>
          </c:marker>
          <c:dPt>
            <c:idx val="0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C8E8-A947-B1DE-3C0D90142DD4}"/>
              </c:ext>
            </c:extLst>
          </c:dPt>
          <c:dPt>
            <c:idx val="1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C8E8-A947-B1DE-3C0D90142DD4}"/>
              </c:ext>
            </c:extLst>
          </c:dPt>
          <c:dPt>
            <c:idx val="2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C8E8-A947-B1DE-3C0D90142DD4}"/>
              </c:ext>
            </c:extLst>
          </c:dPt>
          <c:dPt>
            <c:idx val="3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C8E8-A947-B1DE-3C0D90142DD4}"/>
              </c:ext>
            </c:extLst>
          </c:dPt>
          <c:dPt>
            <c:idx val="4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C8E8-A947-B1DE-3C0D90142DD4}"/>
              </c:ext>
            </c:extLst>
          </c:dPt>
          <c:dPt>
            <c:idx val="43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C8E8-A947-B1DE-3C0D90142DD4}"/>
              </c:ext>
            </c:extLst>
          </c:dPt>
          <c:dPt>
            <c:idx val="87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C8E8-A947-B1DE-3C0D90142DD4}"/>
              </c:ext>
            </c:extLst>
          </c:dPt>
          <c:dPt>
            <c:idx val="95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C8E8-A947-B1DE-3C0D90142DD4}"/>
              </c:ext>
            </c:extLst>
          </c:dPt>
          <c:xVal>
            <c:numRef>
              <c:f>'R278 Data'!$F$15:$F$114</c:f>
              <c:numCache>
                <c:formatCode>General</c:formatCod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numCache>
            </c:numRef>
          </c:xVal>
          <c:yVal>
            <c:numRef>
              <c:f>'R278 Data'!$G$15:$G$114</c:f>
              <c:numCache>
                <c:formatCode>0.0000</c:formatCode>
                <c:ptCount val="100"/>
                <c:pt idx="0">
                  <c:v>0.40860000000000002</c:v>
                </c:pt>
                <c:pt idx="1">
                  <c:v>0.37040000000000001</c:v>
                </c:pt>
                <c:pt idx="2">
                  <c:v>0.33169999999999999</c:v>
                </c:pt>
                <c:pt idx="3">
                  <c:v>0.33040000000000003</c:v>
                </c:pt>
                <c:pt idx="4">
                  <c:v>0.31269999999999998</c:v>
                </c:pt>
                <c:pt idx="5">
                  <c:v>0.28770000000000001</c:v>
                </c:pt>
                <c:pt idx="6">
                  <c:v>0.25580000000000003</c:v>
                </c:pt>
                <c:pt idx="7">
                  <c:v>0.20150000000000001</c:v>
                </c:pt>
                <c:pt idx="8">
                  <c:v>0.1726</c:v>
                </c:pt>
                <c:pt idx="9">
                  <c:v>0.16950000000000001</c:v>
                </c:pt>
                <c:pt idx="10">
                  <c:v>0.16309999999999999</c:v>
                </c:pt>
                <c:pt idx="11">
                  <c:v>0.14979999999999999</c:v>
                </c:pt>
                <c:pt idx="12">
                  <c:v>0.1489</c:v>
                </c:pt>
                <c:pt idx="13">
                  <c:v>0.14829999999999999</c:v>
                </c:pt>
                <c:pt idx="14">
                  <c:v>0.1472</c:v>
                </c:pt>
                <c:pt idx="15">
                  <c:v>0.14480000000000001</c:v>
                </c:pt>
                <c:pt idx="16">
                  <c:v>0.1371</c:v>
                </c:pt>
                <c:pt idx="17">
                  <c:v>0.13370000000000001</c:v>
                </c:pt>
                <c:pt idx="18">
                  <c:v>0.13200000000000001</c:v>
                </c:pt>
                <c:pt idx="19">
                  <c:v>0.1318</c:v>
                </c:pt>
                <c:pt idx="20">
                  <c:v>0.13109999999999999</c:v>
                </c:pt>
                <c:pt idx="21">
                  <c:v>0.127</c:v>
                </c:pt>
                <c:pt idx="22">
                  <c:v>0.12590000000000001</c:v>
                </c:pt>
                <c:pt idx="23">
                  <c:v>0.12570000000000001</c:v>
                </c:pt>
                <c:pt idx="24">
                  <c:v>0.1239</c:v>
                </c:pt>
                <c:pt idx="25">
                  <c:v>0.12330000000000001</c:v>
                </c:pt>
                <c:pt idx="26">
                  <c:v>0.1202</c:v>
                </c:pt>
                <c:pt idx="27">
                  <c:v>0.1202</c:v>
                </c:pt>
                <c:pt idx="28">
                  <c:v>0.11940000000000001</c:v>
                </c:pt>
                <c:pt idx="29">
                  <c:v>0.1178</c:v>
                </c:pt>
                <c:pt idx="30">
                  <c:v>0.1166</c:v>
                </c:pt>
                <c:pt idx="31">
                  <c:v>0.1125</c:v>
                </c:pt>
                <c:pt idx="32">
                  <c:v>0.1124</c:v>
                </c:pt>
                <c:pt idx="33">
                  <c:v>0.11169999999999999</c:v>
                </c:pt>
                <c:pt idx="34">
                  <c:v>0.1115</c:v>
                </c:pt>
                <c:pt idx="35">
                  <c:v>0.1113</c:v>
                </c:pt>
                <c:pt idx="36">
                  <c:v>0.1111</c:v>
                </c:pt>
                <c:pt idx="37">
                  <c:v>0.10979999999999999</c:v>
                </c:pt>
                <c:pt idx="38">
                  <c:v>0.10970000000000001</c:v>
                </c:pt>
                <c:pt idx="39">
                  <c:v>0.109</c:v>
                </c:pt>
                <c:pt idx="40">
                  <c:v>0.109</c:v>
                </c:pt>
                <c:pt idx="41">
                  <c:v>0.10580000000000001</c:v>
                </c:pt>
                <c:pt idx="42">
                  <c:v>0.1053</c:v>
                </c:pt>
                <c:pt idx="43">
                  <c:v>0.10489999999999999</c:v>
                </c:pt>
                <c:pt idx="44">
                  <c:v>0.10489999999999999</c:v>
                </c:pt>
                <c:pt idx="45">
                  <c:v>0.10199999999999999</c:v>
                </c:pt>
                <c:pt idx="46">
                  <c:v>0.1017</c:v>
                </c:pt>
                <c:pt idx="47">
                  <c:v>0.10150000000000001</c:v>
                </c:pt>
                <c:pt idx="48">
                  <c:v>0.10150000000000001</c:v>
                </c:pt>
                <c:pt idx="49">
                  <c:v>0.1002</c:v>
                </c:pt>
                <c:pt idx="50">
                  <c:v>9.9900000000000003E-2</c:v>
                </c:pt>
                <c:pt idx="51">
                  <c:v>9.8900000000000002E-2</c:v>
                </c:pt>
                <c:pt idx="52">
                  <c:v>9.8599999999999993E-2</c:v>
                </c:pt>
                <c:pt idx="53">
                  <c:v>9.8199999999999996E-2</c:v>
                </c:pt>
                <c:pt idx="54">
                  <c:v>9.7799999999999998E-2</c:v>
                </c:pt>
                <c:pt idx="55">
                  <c:v>9.7799999999999998E-2</c:v>
                </c:pt>
                <c:pt idx="56">
                  <c:v>9.7500000000000003E-2</c:v>
                </c:pt>
                <c:pt idx="57">
                  <c:v>9.69E-2</c:v>
                </c:pt>
                <c:pt idx="58">
                  <c:v>9.64E-2</c:v>
                </c:pt>
                <c:pt idx="59">
                  <c:v>9.5699999999999993E-2</c:v>
                </c:pt>
                <c:pt idx="60">
                  <c:v>9.5500000000000002E-2</c:v>
                </c:pt>
                <c:pt idx="61">
                  <c:v>9.5100000000000004E-2</c:v>
                </c:pt>
                <c:pt idx="62">
                  <c:v>9.3399999999999997E-2</c:v>
                </c:pt>
                <c:pt idx="63">
                  <c:v>9.3100000000000002E-2</c:v>
                </c:pt>
                <c:pt idx="64">
                  <c:v>9.2799999999999994E-2</c:v>
                </c:pt>
                <c:pt idx="65">
                  <c:v>9.2799999999999994E-2</c:v>
                </c:pt>
                <c:pt idx="66">
                  <c:v>9.2700000000000005E-2</c:v>
                </c:pt>
                <c:pt idx="67">
                  <c:v>9.1999999999999998E-2</c:v>
                </c:pt>
                <c:pt idx="68">
                  <c:v>9.1399999999999995E-2</c:v>
                </c:pt>
                <c:pt idx="69">
                  <c:v>9.1200000000000003E-2</c:v>
                </c:pt>
                <c:pt idx="70">
                  <c:v>9.0200000000000002E-2</c:v>
                </c:pt>
                <c:pt idx="71">
                  <c:v>8.9599999999999999E-2</c:v>
                </c:pt>
                <c:pt idx="72">
                  <c:v>8.9399999999999993E-2</c:v>
                </c:pt>
                <c:pt idx="73">
                  <c:v>8.8499999999999995E-2</c:v>
                </c:pt>
                <c:pt idx="74">
                  <c:v>8.8200000000000001E-2</c:v>
                </c:pt>
                <c:pt idx="75">
                  <c:v>8.6499999999999994E-2</c:v>
                </c:pt>
                <c:pt idx="76">
                  <c:v>8.6400000000000005E-2</c:v>
                </c:pt>
                <c:pt idx="77">
                  <c:v>8.6199999999999999E-2</c:v>
                </c:pt>
                <c:pt idx="78">
                  <c:v>8.6199999999999999E-2</c:v>
                </c:pt>
                <c:pt idx="79">
                  <c:v>8.6199999999999999E-2</c:v>
                </c:pt>
                <c:pt idx="80">
                  <c:v>8.4900000000000003E-2</c:v>
                </c:pt>
                <c:pt idx="81">
                  <c:v>8.4400000000000003E-2</c:v>
                </c:pt>
                <c:pt idx="82">
                  <c:v>8.43E-2</c:v>
                </c:pt>
                <c:pt idx="83">
                  <c:v>8.3500000000000005E-2</c:v>
                </c:pt>
                <c:pt idx="84">
                  <c:v>8.2799999999999999E-2</c:v>
                </c:pt>
                <c:pt idx="85">
                  <c:v>8.1299999999999997E-2</c:v>
                </c:pt>
                <c:pt idx="86">
                  <c:v>8.0699999999999994E-2</c:v>
                </c:pt>
                <c:pt idx="87">
                  <c:v>8.0299999999999996E-2</c:v>
                </c:pt>
                <c:pt idx="88">
                  <c:v>8.0199999999999994E-2</c:v>
                </c:pt>
                <c:pt idx="89">
                  <c:v>7.9899999999999999E-2</c:v>
                </c:pt>
                <c:pt idx="90">
                  <c:v>7.6399999999999996E-2</c:v>
                </c:pt>
                <c:pt idx="91">
                  <c:v>7.4899999999999994E-2</c:v>
                </c:pt>
                <c:pt idx="92">
                  <c:v>7.4399999999999994E-2</c:v>
                </c:pt>
                <c:pt idx="93">
                  <c:v>7.3499999999999996E-2</c:v>
                </c:pt>
                <c:pt idx="94">
                  <c:v>7.1099999999999997E-2</c:v>
                </c:pt>
                <c:pt idx="95">
                  <c:v>6.729999999999999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C8E8-A947-B1DE-3C0D90142D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29012352"/>
        <c:axId val="576626976"/>
      </c:scatterChart>
      <c:valAx>
        <c:axId val="1629012352"/>
        <c:scaling>
          <c:orientation val="minMax"/>
          <c:max val="1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Clone Number (sorted high to low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6626976"/>
        <c:crosses val="autoZero"/>
        <c:crossBetween val="midCat"/>
        <c:majorUnit val="20"/>
      </c:valAx>
      <c:valAx>
        <c:axId val="576626976"/>
        <c:scaling>
          <c:orientation val="minMax"/>
          <c:max val="0.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OD45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290123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/>
              <a:t>T26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268F Data'!$F$12</c:f>
              <c:strCache>
                <c:ptCount val="1"/>
                <c:pt idx="0">
                  <c:v>ELISA OD4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  <a:prstDash val="solid"/>
              </a:ln>
              <a:effectLst/>
            </c:spPr>
          </c:marker>
          <c:dPt>
            <c:idx val="0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C121-D947-B3C0-D5C87AEA8BFA}"/>
              </c:ext>
            </c:extLst>
          </c:dPt>
          <c:dPt>
            <c:idx val="1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C121-D947-B3C0-D5C87AEA8BFA}"/>
              </c:ext>
            </c:extLst>
          </c:dPt>
          <c:dPt>
            <c:idx val="2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C121-D947-B3C0-D5C87AEA8BFA}"/>
              </c:ext>
            </c:extLst>
          </c:dPt>
          <c:dPt>
            <c:idx val="4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C121-D947-B3C0-D5C87AEA8BFA}"/>
              </c:ext>
            </c:extLst>
          </c:dPt>
          <c:dPt>
            <c:idx val="5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C121-D947-B3C0-D5C87AEA8BFA}"/>
              </c:ext>
            </c:extLst>
          </c:dPt>
          <c:dPt>
            <c:idx val="9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C121-D947-B3C0-D5C87AEA8BFA}"/>
              </c:ext>
            </c:extLst>
          </c:dPt>
          <c:dPt>
            <c:idx val="15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C121-D947-B3C0-D5C87AEA8BFA}"/>
              </c:ext>
            </c:extLst>
          </c:dPt>
          <c:dPt>
            <c:idx val="27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C121-D947-B3C0-D5C87AEA8BFA}"/>
              </c:ext>
            </c:extLst>
          </c:dPt>
          <c:dPt>
            <c:idx val="40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C121-D947-B3C0-D5C87AEA8BFA}"/>
              </c:ext>
            </c:extLst>
          </c:dPt>
          <c:dPt>
            <c:idx val="90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C121-D947-B3C0-D5C87AEA8BFA}"/>
              </c:ext>
            </c:extLst>
          </c:dPt>
          <c:dPt>
            <c:idx val="92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C121-D947-B3C0-D5C87AEA8BFA}"/>
              </c:ext>
            </c:extLst>
          </c:dPt>
          <c:dPt>
            <c:idx val="93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C-C121-D947-B3C0-D5C87AEA8BFA}"/>
              </c:ext>
            </c:extLst>
          </c:dPt>
          <c:xVal>
            <c:numRef>
              <c:f>'T268F Data'!$E$13:$E$112</c:f>
              <c:numCache>
                <c:formatCode>General</c:formatCod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numCache>
            </c:numRef>
          </c:xVal>
          <c:yVal>
            <c:numRef>
              <c:f>'T268F Data'!$F$13:$F$112</c:f>
              <c:numCache>
                <c:formatCode>General</c:formatCode>
                <c:ptCount val="100"/>
                <c:pt idx="0">
                  <c:v>0.53410000000000002</c:v>
                </c:pt>
                <c:pt idx="1">
                  <c:v>0.39750000000000002</c:v>
                </c:pt>
                <c:pt idx="2">
                  <c:v>0.36530000000000001</c:v>
                </c:pt>
                <c:pt idx="3">
                  <c:v>0.35639999999999999</c:v>
                </c:pt>
                <c:pt idx="4">
                  <c:v>0.32119999999999999</c:v>
                </c:pt>
                <c:pt idx="5">
                  <c:v>0.3165</c:v>
                </c:pt>
                <c:pt idx="6">
                  <c:v>0.31369999999999998</c:v>
                </c:pt>
                <c:pt idx="7">
                  <c:v>0.30909999999999999</c:v>
                </c:pt>
                <c:pt idx="8">
                  <c:v>0.3049</c:v>
                </c:pt>
                <c:pt idx="9">
                  <c:v>0.3039</c:v>
                </c:pt>
                <c:pt idx="10">
                  <c:v>0.30359999999999998</c:v>
                </c:pt>
                <c:pt idx="11">
                  <c:v>0.30330000000000001</c:v>
                </c:pt>
                <c:pt idx="12">
                  <c:v>0.29399999999999998</c:v>
                </c:pt>
                <c:pt idx="13">
                  <c:v>0.28939999999999999</c:v>
                </c:pt>
                <c:pt idx="14">
                  <c:v>0.28599999999999998</c:v>
                </c:pt>
                <c:pt idx="15">
                  <c:v>0.28520000000000001</c:v>
                </c:pt>
                <c:pt idx="16">
                  <c:v>0.28199999999999997</c:v>
                </c:pt>
                <c:pt idx="17">
                  <c:v>0.28079999999999999</c:v>
                </c:pt>
                <c:pt idx="18">
                  <c:v>0.27829999999999999</c:v>
                </c:pt>
                <c:pt idx="19">
                  <c:v>0.27229999999999999</c:v>
                </c:pt>
                <c:pt idx="20">
                  <c:v>0.27100000000000002</c:v>
                </c:pt>
                <c:pt idx="21">
                  <c:v>0.2671</c:v>
                </c:pt>
                <c:pt idx="22">
                  <c:v>0.2596</c:v>
                </c:pt>
                <c:pt idx="23">
                  <c:v>0.25940000000000002</c:v>
                </c:pt>
                <c:pt idx="24">
                  <c:v>0.25890000000000002</c:v>
                </c:pt>
                <c:pt idx="25">
                  <c:v>0.25580000000000003</c:v>
                </c:pt>
                <c:pt idx="26">
                  <c:v>0.25369999999999998</c:v>
                </c:pt>
                <c:pt idx="27">
                  <c:v>0.25190000000000001</c:v>
                </c:pt>
                <c:pt idx="28">
                  <c:v>0.25059999999999999</c:v>
                </c:pt>
                <c:pt idx="29">
                  <c:v>0.2505</c:v>
                </c:pt>
                <c:pt idx="30">
                  <c:v>0.24490000000000001</c:v>
                </c:pt>
                <c:pt idx="31">
                  <c:v>0.23350000000000001</c:v>
                </c:pt>
                <c:pt idx="32">
                  <c:v>0.2311</c:v>
                </c:pt>
                <c:pt idx="33">
                  <c:v>0.22700000000000001</c:v>
                </c:pt>
                <c:pt idx="34">
                  <c:v>0.22559999999999999</c:v>
                </c:pt>
                <c:pt idx="35">
                  <c:v>0.22459999999999999</c:v>
                </c:pt>
                <c:pt idx="36">
                  <c:v>0.21940000000000001</c:v>
                </c:pt>
                <c:pt idx="37">
                  <c:v>0.21240000000000001</c:v>
                </c:pt>
                <c:pt idx="38">
                  <c:v>0.21210000000000001</c:v>
                </c:pt>
                <c:pt idx="39">
                  <c:v>0.21129999999999999</c:v>
                </c:pt>
                <c:pt idx="40">
                  <c:v>0.20860000000000001</c:v>
                </c:pt>
                <c:pt idx="41">
                  <c:v>0.2079</c:v>
                </c:pt>
                <c:pt idx="42">
                  <c:v>0.20749999999999999</c:v>
                </c:pt>
                <c:pt idx="43">
                  <c:v>0.2069</c:v>
                </c:pt>
                <c:pt idx="44">
                  <c:v>0.2051</c:v>
                </c:pt>
                <c:pt idx="45">
                  <c:v>0.19800000000000001</c:v>
                </c:pt>
                <c:pt idx="46">
                  <c:v>0.19539999999999999</c:v>
                </c:pt>
                <c:pt idx="47">
                  <c:v>0.19409999999999999</c:v>
                </c:pt>
                <c:pt idx="48">
                  <c:v>0.19209999999999999</c:v>
                </c:pt>
                <c:pt idx="49">
                  <c:v>0.1908</c:v>
                </c:pt>
                <c:pt idx="50">
                  <c:v>0.1883</c:v>
                </c:pt>
                <c:pt idx="51">
                  <c:v>0.18490000000000001</c:v>
                </c:pt>
                <c:pt idx="52">
                  <c:v>0.1744</c:v>
                </c:pt>
                <c:pt idx="53">
                  <c:v>0.1714</c:v>
                </c:pt>
                <c:pt idx="54">
                  <c:v>0.17080000000000001</c:v>
                </c:pt>
                <c:pt idx="55">
                  <c:v>0.16950000000000001</c:v>
                </c:pt>
                <c:pt idx="56">
                  <c:v>0.1686</c:v>
                </c:pt>
                <c:pt idx="57">
                  <c:v>0.1666</c:v>
                </c:pt>
                <c:pt idx="58">
                  <c:v>0.16550000000000001</c:v>
                </c:pt>
                <c:pt idx="59">
                  <c:v>0.16500000000000001</c:v>
                </c:pt>
                <c:pt idx="60">
                  <c:v>0.16420000000000001</c:v>
                </c:pt>
                <c:pt idx="61">
                  <c:v>0.16339999999999999</c:v>
                </c:pt>
                <c:pt idx="62">
                  <c:v>0.16209999999999999</c:v>
                </c:pt>
                <c:pt idx="63">
                  <c:v>0.16009999999999999</c:v>
                </c:pt>
                <c:pt idx="64">
                  <c:v>0.15709999999999999</c:v>
                </c:pt>
                <c:pt idx="65">
                  <c:v>0.157</c:v>
                </c:pt>
                <c:pt idx="66">
                  <c:v>0.15629999999999999</c:v>
                </c:pt>
                <c:pt idx="67">
                  <c:v>0.15590000000000001</c:v>
                </c:pt>
                <c:pt idx="68">
                  <c:v>0.15540000000000001</c:v>
                </c:pt>
                <c:pt idx="69">
                  <c:v>0.15459999999999999</c:v>
                </c:pt>
                <c:pt idx="70">
                  <c:v>0.15440000000000001</c:v>
                </c:pt>
                <c:pt idx="71">
                  <c:v>0.15409999999999999</c:v>
                </c:pt>
                <c:pt idx="72">
                  <c:v>0.15060000000000001</c:v>
                </c:pt>
                <c:pt idx="73">
                  <c:v>0.14449999999999999</c:v>
                </c:pt>
                <c:pt idx="74">
                  <c:v>0.14230000000000001</c:v>
                </c:pt>
                <c:pt idx="75">
                  <c:v>0.13550000000000001</c:v>
                </c:pt>
                <c:pt idx="76">
                  <c:v>0.13150000000000001</c:v>
                </c:pt>
                <c:pt idx="77">
                  <c:v>0.13120000000000001</c:v>
                </c:pt>
                <c:pt idx="78">
                  <c:v>0.1298</c:v>
                </c:pt>
                <c:pt idx="79">
                  <c:v>0.1283</c:v>
                </c:pt>
                <c:pt idx="80">
                  <c:v>0.12609999999999999</c:v>
                </c:pt>
                <c:pt idx="81">
                  <c:v>0.12570000000000001</c:v>
                </c:pt>
                <c:pt idx="82">
                  <c:v>0.1246</c:v>
                </c:pt>
                <c:pt idx="83">
                  <c:v>0.12280000000000001</c:v>
                </c:pt>
                <c:pt idx="84">
                  <c:v>0.12089999999999999</c:v>
                </c:pt>
                <c:pt idx="85">
                  <c:v>0.1193</c:v>
                </c:pt>
                <c:pt idx="86">
                  <c:v>0.11360000000000001</c:v>
                </c:pt>
                <c:pt idx="87">
                  <c:v>0.107</c:v>
                </c:pt>
                <c:pt idx="88">
                  <c:v>0.1046</c:v>
                </c:pt>
                <c:pt idx="89">
                  <c:v>0.1041</c:v>
                </c:pt>
                <c:pt idx="90">
                  <c:v>0.1031</c:v>
                </c:pt>
                <c:pt idx="91">
                  <c:v>0.1008</c:v>
                </c:pt>
                <c:pt idx="92">
                  <c:v>0.1003</c:v>
                </c:pt>
                <c:pt idx="93">
                  <c:v>9.8500000000000004E-2</c:v>
                </c:pt>
                <c:pt idx="94">
                  <c:v>9.5500000000000002E-2</c:v>
                </c:pt>
                <c:pt idx="95">
                  <c:v>9.420000000000000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C121-D947-B3C0-D5C87AEA8B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9498543"/>
        <c:axId val="376547807"/>
      </c:scatterChart>
      <c:valAx>
        <c:axId val="609498543"/>
        <c:scaling>
          <c:orientation val="minMax"/>
          <c:max val="100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Clone Number (sorted high to low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547807"/>
        <c:crosses val="autoZero"/>
        <c:crossBetween val="midCat"/>
      </c:valAx>
      <c:valAx>
        <c:axId val="37654780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OD45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949854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/>
              <a:t>K31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K312E Data'!$F$13</c:f>
              <c:strCache>
                <c:ptCount val="1"/>
                <c:pt idx="0">
                  <c:v>ELISA OD45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12700">
                <a:solidFill>
                  <a:schemeClr val="tx1"/>
                </a:solidFill>
                <a:prstDash val="solid"/>
              </a:ln>
              <a:effectLst/>
            </c:spPr>
          </c:marker>
          <c:dPt>
            <c:idx val="0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35F8-B146-AB84-3FB763169562}"/>
              </c:ext>
            </c:extLst>
          </c:dPt>
          <c:dPt>
            <c:idx val="1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35F8-B146-AB84-3FB763169562}"/>
              </c:ext>
            </c:extLst>
          </c:dPt>
          <c:dPt>
            <c:idx val="2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35F8-B146-AB84-3FB763169562}"/>
              </c:ext>
            </c:extLst>
          </c:dPt>
          <c:dPt>
            <c:idx val="3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35F8-B146-AB84-3FB763169562}"/>
              </c:ext>
            </c:extLst>
          </c:dPt>
          <c:dPt>
            <c:idx val="4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35F8-B146-AB84-3FB763169562}"/>
              </c:ext>
            </c:extLst>
          </c:dPt>
          <c:dPt>
            <c:idx val="6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35F8-B146-AB84-3FB763169562}"/>
              </c:ext>
            </c:extLst>
          </c:dPt>
          <c:dPt>
            <c:idx val="10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35F8-B146-AB84-3FB763169562}"/>
              </c:ext>
            </c:extLst>
          </c:dPt>
          <c:dPt>
            <c:idx val="11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35F8-B146-AB84-3FB763169562}"/>
              </c:ext>
            </c:extLst>
          </c:dPt>
          <c:dPt>
            <c:idx val="24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35F8-B146-AB84-3FB763169562}"/>
              </c:ext>
            </c:extLst>
          </c:dPt>
          <c:dPt>
            <c:idx val="47"/>
            <c:marker>
              <c:symbol val="circle"/>
              <c:size val="8"/>
              <c:spPr>
                <a:solidFill>
                  <a:srgbClr val="62E962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35F8-B146-AB84-3FB763169562}"/>
              </c:ext>
            </c:extLst>
          </c:dPt>
          <c:dPt>
            <c:idx val="58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35F8-B146-AB84-3FB763169562}"/>
              </c:ext>
            </c:extLst>
          </c:dPt>
          <c:dPt>
            <c:idx val="80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35F8-B146-AB84-3FB763169562}"/>
              </c:ext>
            </c:extLst>
          </c:dPt>
          <c:dPt>
            <c:idx val="87"/>
            <c:marker>
              <c:symbol val="triang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C-35F8-B146-AB84-3FB763169562}"/>
              </c:ext>
            </c:extLst>
          </c:dPt>
          <c:dPt>
            <c:idx val="91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D-35F8-B146-AB84-3FB763169562}"/>
              </c:ext>
            </c:extLst>
          </c:dPt>
          <c:dPt>
            <c:idx val="93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E-35F8-B146-AB84-3FB763169562}"/>
              </c:ext>
            </c:extLst>
          </c:dPt>
          <c:dPt>
            <c:idx val="94"/>
            <c:marker>
              <c:symbol val="circle"/>
              <c:size val="8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F-35F8-B146-AB84-3FB763169562}"/>
              </c:ext>
            </c:extLst>
          </c:dPt>
          <c:dPt>
            <c:idx val="95"/>
            <c:marker>
              <c:symbol val="square"/>
              <c:size val="8"/>
              <c:spPr>
                <a:solidFill>
                  <a:srgbClr val="FB8814"/>
                </a:solidFill>
                <a:ln w="12700">
                  <a:solidFill>
                    <a:schemeClr val="tx1"/>
                  </a:solidFill>
                  <a:prstDash val="solid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35F8-B146-AB84-3FB763169562}"/>
              </c:ext>
            </c:extLst>
          </c:dPt>
          <c:xVal>
            <c:numRef>
              <c:f>'K312E Data'!$E$14:$E$113</c:f>
              <c:numCache>
                <c:formatCode>General</c:formatCod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numCache>
            </c:numRef>
          </c:xVal>
          <c:yVal>
            <c:numRef>
              <c:f>'K312E Data'!$F$14:$F$113</c:f>
              <c:numCache>
                <c:formatCode>0.0000</c:formatCode>
                <c:ptCount val="100"/>
                <c:pt idx="0">
                  <c:v>0.47910000000000003</c:v>
                </c:pt>
                <c:pt idx="1">
                  <c:v>0.45800000000000002</c:v>
                </c:pt>
                <c:pt idx="2">
                  <c:v>0.4481</c:v>
                </c:pt>
                <c:pt idx="3">
                  <c:v>0.42009999999999997</c:v>
                </c:pt>
                <c:pt idx="4">
                  <c:v>0.41639999999999999</c:v>
                </c:pt>
                <c:pt idx="5">
                  <c:v>0.40310000000000001</c:v>
                </c:pt>
                <c:pt idx="6">
                  <c:v>0.4027</c:v>
                </c:pt>
                <c:pt idx="7">
                  <c:v>0.3931</c:v>
                </c:pt>
                <c:pt idx="8">
                  <c:v>0.39029999999999998</c:v>
                </c:pt>
                <c:pt idx="9">
                  <c:v>0.38750000000000001</c:v>
                </c:pt>
                <c:pt idx="10">
                  <c:v>0.38550000000000001</c:v>
                </c:pt>
                <c:pt idx="11">
                  <c:v>0.3775</c:v>
                </c:pt>
                <c:pt idx="12">
                  <c:v>0.37069999999999997</c:v>
                </c:pt>
                <c:pt idx="13">
                  <c:v>0.36409999999999998</c:v>
                </c:pt>
                <c:pt idx="14">
                  <c:v>0.36120000000000002</c:v>
                </c:pt>
                <c:pt idx="15">
                  <c:v>0.35799999999999998</c:v>
                </c:pt>
                <c:pt idx="16">
                  <c:v>0.35360000000000003</c:v>
                </c:pt>
                <c:pt idx="17">
                  <c:v>0.35310000000000002</c:v>
                </c:pt>
                <c:pt idx="18">
                  <c:v>0.34160000000000001</c:v>
                </c:pt>
                <c:pt idx="19">
                  <c:v>0.33660000000000001</c:v>
                </c:pt>
                <c:pt idx="20">
                  <c:v>0.33539999999999998</c:v>
                </c:pt>
                <c:pt idx="21">
                  <c:v>0.3337</c:v>
                </c:pt>
                <c:pt idx="22">
                  <c:v>0.33069999999999999</c:v>
                </c:pt>
                <c:pt idx="23">
                  <c:v>0.32469999999999999</c:v>
                </c:pt>
                <c:pt idx="24">
                  <c:v>0.3241</c:v>
                </c:pt>
                <c:pt idx="25">
                  <c:v>0.32379999999999998</c:v>
                </c:pt>
                <c:pt idx="26">
                  <c:v>0.318</c:v>
                </c:pt>
                <c:pt idx="27">
                  <c:v>0.31209999999999999</c:v>
                </c:pt>
                <c:pt idx="28">
                  <c:v>0.30690000000000001</c:v>
                </c:pt>
                <c:pt idx="29">
                  <c:v>0.30380000000000001</c:v>
                </c:pt>
                <c:pt idx="30">
                  <c:v>0.30370000000000003</c:v>
                </c:pt>
                <c:pt idx="31">
                  <c:v>0.29820000000000002</c:v>
                </c:pt>
                <c:pt idx="32">
                  <c:v>0.29720000000000002</c:v>
                </c:pt>
                <c:pt idx="33">
                  <c:v>0.2954</c:v>
                </c:pt>
                <c:pt idx="34">
                  <c:v>0.2949</c:v>
                </c:pt>
                <c:pt idx="35">
                  <c:v>0.29339999999999999</c:v>
                </c:pt>
                <c:pt idx="36">
                  <c:v>0.28749999999999998</c:v>
                </c:pt>
                <c:pt idx="37">
                  <c:v>0.28449999999999998</c:v>
                </c:pt>
                <c:pt idx="38">
                  <c:v>0.28439999999999999</c:v>
                </c:pt>
                <c:pt idx="39">
                  <c:v>0.28299999999999997</c:v>
                </c:pt>
                <c:pt idx="40">
                  <c:v>0.28139999999999998</c:v>
                </c:pt>
                <c:pt idx="41">
                  <c:v>0.27989999999999998</c:v>
                </c:pt>
                <c:pt idx="42">
                  <c:v>0.27829999999999999</c:v>
                </c:pt>
                <c:pt idx="43">
                  <c:v>0.27810000000000001</c:v>
                </c:pt>
                <c:pt idx="44">
                  <c:v>0.27650000000000002</c:v>
                </c:pt>
                <c:pt idx="45">
                  <c:v>0.27450000000000002</c:v>
                </c:pt>
                <c:pt idx="46">
                  <c:v>0.27379999999999999</c:v>
                </c:pt>
                <c:pt idx="47">
                  <c:v>0.27100000000000002</c:v>
                </c:pt>
                <c:pt idx="48">
                  <c:v>0.26910000000000001</c:v>
                </c:pt>
                <c:pt idx="49">
                  <c:v>0.26579999999999998</c:v>
                </c:pt>
                <c:pt idx="50">
                  <c:v>0.26579999999999998</c:v>
                </c:pt>
                <c:pt idx="51">
                  <c:v>0.26519999999999999</c:v>
                </c:pt>
                <c:pt idx="52">
                  <c:v>0.26440000000000002</c:v>
                </c:pt>
                <c:pt idx="53">
                  <c:v>0.26390000000000002</c:v>
                </c:pt>
                <c:pt idx="54">
                  <c:v>0.2636</c:v>
                </c:pt>
                <c:pt idx="55">
                  <c:v>0.26279999999999998</c:v>
                </c:pt>
                <c:pt idx="56">
                  <c:v>0.26</c:v>
                </c:pt>
                <c:pt idx="57">
                  <c:v>0.25890000000000002</c:v>
                </c:pt>
                <c:pt idx="58">
                  <c:v>0.25729999999999997</c:v>
                </c:pt>
                <c:pt idx="59">
                  <c:v>0.25359999999999999</c:v>
                </c:pt>
                <c:pt idx="60">
                  <c:v>0.2475</c:v>
                </c:pt>
                <c:pt idx="61">
                  <c:v>0.2472</c:v>
                </c:pt>
                <c:pt idx="62">
                  <c:v>0.2465</c:v>
                </c:pt>
                <c:pt idx="63">
                  <c:v>0.24260000000000001</c:v>
                </c:pt>
                <c:pt idx="64">
                  <c:v>0.23849999999999999</c:v>
                </c:pt>
                <c:pt idx="65">
                  <c:v>0.2374</c:v>
                </c:pt>
                <c:pt idx="66">
                  <c:v>0.23350000000000001</c:v>
                </c:pt>
                <c:pt idx="67">
                  <c:v>0.2319</c:v>
                </c:pt>
                <c:pt idx="68">
                  <c:v>0.23080000000000001</c:v>
                </c:pt>
                <c:pt idx="69">
                  <c:v>0.23069999999999999</c:v>
                </c:pt>
                <c:pt idx="70">
                  <c:v>0.23039999999999999</c:v>
                </c:pt>
                <c:pt idx="71">
                  <c:v>0.2271</c:v>
                </c:pt>
                <c:pt idx="72">
                  <c:v>0.22689999999999999</c:v>
                </c:pt>
                <c:pt idx="73">
                  <c:v>0.22620000000000001</c:v>
                </c:pt>
                <c:pt idx="74">
                  <c:v>0.22620000000000001</c:v>
                </c:pt>
                <c:pt idx="75">
                  <c:v>0.22589999999999999</c:v>
                </c:pt>
                <c:pt idx="76">
                  <c:v>0.22550000000000001</c:v>
                </c:pt>
                <c:pt idx="77">
                  <c:v>0.2213</c:v>
                </c:pt>
                <c:pt idx="78">
                  <c:v>0.22</c:v>
                </c:pt>
                <c:pt idx="79">
                  <c:v>0.21959999999999999</c:v>
                </c:pt>
                <c:pt idx="80">
                  <c:v>0.219</c:v>
                </c:pt>
                <c:pt idx="81">
                  <c:v>0.21870000000000001</c:v>
                </c:pt>
                <c:pt idx="82">
                  <c:v>0.21740000000000001</c:v>
                </c:pt>
                <c:pt idx="83">
                  <c:v>0.2172</c:v>
                </c:pt>
                <c:pt idx="84">
                  <c:v>0.21579999999999999</c:v>
                </c:pt>
                <c:pt idx="85">
                  <c:v>0.2152</c:v>
                </c:pt>
                <c:pt idx="86">
                  <c:v>0.21260000000000001</c:v>
                </c:pt>
                <c:pt idx="87">
                  <c:v>0.20749999999999999</c:v>
                </c:pt>
                <c:pt idx="88">
                  <c:v>0.2019</c:v>
                </c:pt>
                <c:pt idx="89">
                  <c:v>0.20050000000000001</c:v>
                </c:pt>
                <c:pt idx="90">
                  <c:v>0.19939999999999999</c:v>
                </c:pt>
                <c:pt idx="91">
                  <c:v>0.1207</c:v>
                </c:pt>
                <c:pt idx="92">
                  <c:v>0.1018</c:v>
                </c:pt>
                <c:pt idx="93">
                  <c:v>9.2399999999999996E-2</c:v>
                </c:pt>
                <c:pt idx="94">
                  <c:v>9.1800000000000007E-2</c:v>
                </c:pt>
                <c:pt idx="95">
                  <c:v>9.089999999999999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35F8-B146-AB84-3FB7631695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8225135"/>
        <c:axId val="1487617407"/>
      </c:scatterChart>
      <c:valAx>
        <c:axId val="1988225135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Clone Number (sorted high to low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87617407"/>
        <c:crosses val="autoZero"/>
        <c:crossBetween val="midCat"/>
      </c:valAx>
      <c:valAx>
        <c:axId val="148761740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OD45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8822513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A8CDA8-571B-C249-9C49-85810A5CCB2A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F56D29-93CA-EB4C-92D5-2DFE0E5DE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4069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F56D29-93CA-EB4C-92D5-2DFE0E5DE96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5158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543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003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925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210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221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202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158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03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263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634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959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45FCC3-AA79-1F48-9967-AAF9C3A786D9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8CEABA-A6C4-DF4E-A4EA-61FA3321CB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274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7918C372-02A7-200A-BF18-B33C84E8178B}"/>
              </a:ext>
            </a:extLst>
          </p:cNvPr>
          <p:cNvSpPr txBox="1"/>
          <p:nvPr/>
        </p:nvSpPr>
        <p:spPr>
          <a:xfrm>
            <a:off x="294521" y="11244552"/>
            <a:ext cx="9012158" cy="1015663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0" marR="0" algn="just"/>
            <a:r>
              <a:rPr lang="en-US" sz="1200" b="1" kern="100" dirty="0">
                <a:latin typeface="Arial"/>
                <a:ea typeface="Calibri"/>
                <a:cs typeface="Times New Roman"/>
              </a:rPr>
              <a:t>Figure</a:t>
            </a:r>
            <a:r>
              <a:rPr lang="en-US" sz="1200" b="1" kern="100" dirty="0">
                <a:effectLst/>
                <a:latin typeface="Arial"/>
                <a:ea typeface="Calibri"/>
                <a:cs typeface="Times New Roman"/>
              </a:rPr>
              <a:t> </a:t>
            </a:r>
            <a:r>
              <a:rPr lang="en-US" sz="1200" b="1" kern="100" dirty="0">
                <a:latin typeface="Arial"/>
                <a:ea typeface="Calibri"/>
                <a:cs typeface="Times New Roman"/>
              </a:rPr>
              <a:t>S2</a:t>
            </a:r>
            <a:r>
              <a:rPr lang="en-US" sz="1200" b="1" kern="100" dirty="0">
                <a:effectLst/>
                <a:latin typeface="Arial"/>
                <a:ea typeface="Calibri"/>
                <a:cs typeface="Times New Roman"/>
              </a:rPr>
              <a:t>. 22c library screening identifies amino acid substitutions in </a:t>
            </a:r>
            <a:r>
              <a:rPr lang="en-US" sz="1200" b="1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200" b="1" kern="100" dirty="0">
                <a:effectLst/>
                <a:latin typeface="Arial"/>
                <a:ea typeface="Calibri"/>
                <a:cs typeface="Times New Roman"/>
              </a:rPr>
              <a:t> that improve transfer of the GBSV glycan.</a:t>
            </a:r>
            <a:r>
              <a:rPr lang="en-US" sz="1200" kern="100" dirty="0">
                <a:effectLst/>
                <a:latin typeface="Arial"/>
                <a:ea typeface="Calibri"/>
                <a:cs typeface="Times New Roman"/>
              </a:rPr>
              <a:t> Circles, </a:t>
            </a:r>
            <a:r>
              <a:rPr lang="en-US" sz="1200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200" kern="100" dirty="0">
                <a:effectLst/>
                <a:latin typeface="Arial"/>
                <a:ea typeface="Calibri"/>
                <a:cs typeface="Times New Roman"/>
              </a:rPr>
              <a:t> library clones from R271 (A), R278 (B), N28 (C), T268 (D) and K312 (E); black triangles, positive control clones expressing wildtype </a:t>
            </a:r>
            <a:r>
              <a:rPr lang="en-US" sz="1200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200" kern="100" dirty="0">
                <a:effectLst/>
                <a:latin typeface="Arial"/>
                <a:ea typeface="Calibri"/>
                <a:cs typeface="Times New Roman"/>
              </a:rPr>
              <a:t> (pVNM245); orange squares, negative control clones expressing inactive </a:t>
            </a:r>
            <a:r>
              <a:rPr lang="en-US" sz="1200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200" kern="100" dirty="0">
                <a:effectLst/>
                <a:latin typeface="Arial"/>
                <a:ea typeface="Calibri"/>
                <a:cs typeface="Times New Roman"/>
              </a:rPr>
              <a:t> (pVNM322). Green circles indicate </a:t>
            </a:r>
            <a:r>
              <a:rPr lang="en-US" sz="1200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200" kern="100" dirty="0">
                <a:effectLst/>
                <a:latin typeface="Arial"/>
                <a:ea typeface="Calibri"/>
                <a:cs typeface="Times New Roman"/>
              </a:rPr>
              <a:t> hits </a:t>
            </a:r>
            <a:r>
              <a:rPr lang="en-US" sz="1200" kern="100" dirty="0">
                <a:latin typeface="Arial"/>
                <a:ea typeface="Calibri"/>
                <a:cs typeface="Times New Roman"/>
              </a:rPr>
              <a:t>with amino acids changed</a:t>
            </a:r>
            <a:r>
              <a:rPr lang="en-US" sz="1200" kern="100" dirty="0">
                <a:effectLst/>
                <a:latin typeface="Arial"/>
                <a:ea typeface="Calibri"/>
                <a:cs typeface="Times New Roman"/>
              </a:rPr>
              <a:t> to N28W (C), T268F (D), and K312E (E). Grey dashed line indicates a 1.4-fold cutoff. Black circles indicate </a:t>
            </a:r>
            <a:r>
              <a:rPr lang="en-US" sz="1200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200" kern="100" dirty="0">
                <a:effectLst/>
                <a:latin typeface="Arial"/>
                <a:ea typeface="Calibri"/>
                <a:cs typeface="Times New Roman"/>
              </a:rPr>
              <a:t> clones that were wildtype upon sequencing </a:t>
            </a:r>
          </a:p>
        </p:txBody>
      </p:sp>
      <p:graphicFrame>
        <p:nvGraphicFramePr>
          <p:cNvPr id="6" name="Chart 5" descr="Chart type: Scatter. 'ELISA OD450'&#10;&#10;Description automatically generated">
            <a:extLst>
              <a:ext uri="{FF2B5EF4-FFF2-40B4-BE49-F238E27FC236}">
                <a16:creationId xmlns:a16="http://schemas.microsoft.com/office/drawing/2014/main" id="{692391C6-648F-7D95-A64B-EFF2BA63B6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8654963"/>
              </p:ext>
            </p:extLst>
          </p:nvPr>
        </p:nvGraphicFramePr>
        <p:xfrm>
          <a:off x="250700" y="4004127"/>
          <a:ext cx="4633705" cy="35479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C9B1E37-1E84-8876-54E6-9BBA51E79F1D}"/>
              </a:ext>
            </a:extLst>
          </p:cNvPr>
          <p:cNvSpPr txBox="1"/>
          <p:nvPr/>
        </p:nvSpPr>
        <p:spPr>
          <a:xfrm>
            <a:off x="112571" y="3867876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467AE2E4-0DE2-F519-A6FA-2BC45503347E}"/>
              </a:ext>
            </a:extLst>
          </p:cNvPr>
          <p:cNvCxnSpPr>
            <a:cxnSpLocks/>
          </p:cNvCxnSpPr>
          <p:nvPr/>
        </p:nvCxnSpPr>
        <p:spPr>
          <a:xfrm>
            <a:off x="1619824" y="4454628"/>
            <a:ext cx="0" cy="1574407"/>
          </a:xfrm>
          <a:prstGeom prst="line">
            <a:avLst/>
          </a:prstGeom>
          <a:ln w="28575">
            <a:solidFill>
              <a:schemeClr val="bg1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D01EF8F-43BA-93FC-B347-A4ED126DB8D0}"/>
              </a:ext>
            </a:extLst>
          </p:cNvPr>
          <p:cNvCxnSpPr>
            <a:cxnSpLocks/>
          </p:cNvCxnSpPr>
          <p:nvPr/>
        </p:nvCxnSpPr>
        <p:spPr>
          <a:xfrm>
            <a:off x="1619824" y="6231473"/>
            <a:ext cx="0" cy="667579"/>
          </a:xfrm>
          <a:prstGeom prst="line">
            <a:avLst/>
          </a:prstGeom>
          <a:ln w="28575">
            <a:solidFill>
              <a:schemeClr val="bg1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6" name="Chart 25" descr="Chart type: Scatter. 'ELISA OD450'&#10;&#10;Description automatically generated">
            <a:extLst>
              <a:ext uri="{FF2B5EF4-FFF2-40B4-BE49-F238E27FC236}">
                <a16:creationId xmlns:a16="http://schemas.microsoft.com/office/drawing/2014/main" id="{12A88EF3-06F2-07A7-691A-69E97EF856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4699288"/>
              </p:ext>
            </p:extLst>
          </p:nvPr>
        </p:nvGraphicFramePr>
        <p:xfrm>
          <a:off x="4800600" y="377436"/>
          <a:ext cx="4636008" cy="3547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51E96CE-16B1-367D-BE8E-D854DA847630}"/>
              </a:ext>
            </a:extLst>
          </p:cNvPr>
          <p:cNvSpPr txBox="1"/>
          <p:nvPr/>
        </p:nvSpPr>
        <p:spPr>
          <a:xfrm>
            <a:off x="4821865" y="49540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aphicFrame>
        <p:nvGraphicFramePr>
          <p:cNvPr id="30" name="Chart 29" descr="Chart type: Scatter. 'OD450'&#10;&#10;Description automatically generated">
            <a:extLst>
              <a:ext uri="{FF2B5EF4-FFF2-40B4-BE49-F238E27FC236}">
                <a16:creationId xmlns:a16="http://schemas.microsoft.com/office/drawing/2014/main" id="{1CADB1E5-0965-FE14-B9A6-D6C58EECE0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9968914"/>
              </p:ext>
            </p:extLst>
          </p:nvPr>
        </p:nvGraphicFramePr>
        <p:xfrm>
          <a:off x="250700" y="371404"/>
          <a:ext cx="4636008" cy="3547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1" name="Chart 30" descr="Chart type: Scatter. 'OD450'&#10;&#10;Description automatically generated">
            <a:extLst>
              <a:ext uri="{FF2B5EF4-FFF2-40B4-BE49-F238E27FC236}">
                <a16:creationId xmlns:a16="http://schemas.microsoft.com/office/drawing/2014/main" id="{19E55A12-8CE8-4255-4CD3-C49B31E0A8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6327200"/>
              </p:ext>
            </p:extLst>
          </p:nvPr>
        </p:nvGraphicFramePr>
        <p:xfrm>
          <a:off x="4800600" y="4004127"/>
          <a:ext cx="4636008" cy="3547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0160FA6-B430-B3B7-1F7D-48A67C9CE334}"/>
              </a:ext>
            </a:extLst>
          </p:cNvPr>
          <p:cNvCxnSpPr>
            <a:cxnSpLocks/>
          </p:cNvCxnSpPr>
          <p:nvPr/>
        </p:nvCxnSpPr>
        <p:spPr>
          <a:xfrm>
            <a:off x="5690829" y="4454628"/>
            <a:ext cx="0" cy="930142"/>
          </a:xfrm>
          <a:prstGeom prst="line">
            <a:avLst/>
          </a:prstGeom>
          <a:ln w="28575">
            <a:solidFill>
              <a:schemeClr val="bg1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CACFE78-C695-1E91-86C5-254DC97FA4EA}"/>
              </a:ext>
            </a:extLst>
          </p:cNvPr>
          <p:cNvCxnSpPr>
            <a:cxnSpLocks/>
          </p:cNvCxnSpPr>
          <p:nvPr/>
        </p:nvCxnSpPr>
        <p:spPr>
          <a:xfrm>
            <a:off x="5690829" y="5711928"/>
            <a:ext cx="0" cy="1165796"/>
          </a:xfrm>
          <a:prstGeom prst="line">
            <a:avLst/>
          </a:prstGeom>
          <a:ln w="28575">
            <a:solidFill>
              <a:schemeClr val="bg1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33" name="Chart 32" descr="Chart type: Scatter. 'ELISA OD450'&#10;&#10;Description automatically generated">
            <a:extLst>
              <a:ext uri="{FF2B5EF4-FFF2-40B4-BE49-F238E27FC236}">
                <a16:creationId xmlns:a16="http://schemas.microsoft.com/office/drawing/2014/main" id="{1F75CFFB-64D3-BEE6-23BA-5793934F70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8818243"/>
              </p:ext>
            </p:extLst>
          </p:nvPr>
        </p:nvGraphicFramePr>
        <p:xfrm>
          <a:off x="250700" y="7586308"/>
          <a:ext cx="4636008" cy="3547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53548480-96A1-53CB-DCBB-2A7E9DA43F48}"/>
              </a:ext>
            </a:extLst>
          </p:cNvPr>
          <p:cNvSpPr txBox="1"/>
          <p:nvPr/>
        </p:nvSpPr>
        <p:spPr>
          <a:xfrm>
            <a:off x="112571" y="755557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EE4761E-9F99-E9F2-FACA-12059B9A3CDE}"/>
              </a:ext>
            </a:extLst>
          </p:cNvPr>
          <p:cNvCxnSpPr>
            <a:cxnSpLocks/>
          </p:cNvCxnSpPr>
          <p:nvPr/>
        </p:nvCxnSpPr>
        <p:spPr>
          <a:xfrm>
            <a:off x="1981451" y="8104244"/>
            <a:ext cx="0" cy="991265"/>
          </a:xfrm>
          <a:prstGeom prst="line">
            <a:avLst/>
          </a:prstGeom>
          <a:ln w="28575">
            <a:solidFill>
              <a:schemeClr val="bg1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4E35349D-84FA-2099-8DF5-A4BD76A50EFD}"/>
              </a:ext>
            </a:extLst>
          </p:cNvPr>
          <p:cNvCxnSpPr>
            <a:cxnSpLocks/>
          </p:cNvCxnSpPr>
          <p:nvPr/>
        </p:nvCxnSpPr>
        <p:spPr>
          <a:xfrm>
            <a:off x="1971187" y="9284207"/>
            <a:ext cx="0" cy="1198320"/>
          </a:xfrm>
          <a:prstGeom prst="line">
            <a:avLst/>
          </a:prstGeom>
          <a:ln w="28575">
            <a:solidFill>
              <a:schemeClr val="bg1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48561EFA-4480-9B2F-7897-EA5B114AFE85}"/>
              </a:ext>
            </a:extLst>
          </p:cNvPr>
          <p:cNvSpPr txBox="1"/>
          <p:nvPr/>
        </p:nvSpPr>
        <p:spPr>
          <a:xfrm>
            <a:off x="112571" y="495408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1141318-12F7-A014-92CF-D6AE3374C93C}"/>
              </a:ext>
            </a:extLst>
          </p:cNvPr>
          <p:cNvSpPr txBox="1"/>
          <p:nvPr/>
        </p:nvSpPr>
        <p:spPr>
          <a:xfrm>
            <a:off x="4800600" y="3867876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89592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MigrationWizIdVersion xmlns="324db12f-297c-40e3-86f6-4d82186512ff" xsi:nil="true"/>
    <lcf76f155ced4ddcb4097134ff3c332f xmlns="324db12f-297c-40e3-86f6-4d82186512ff">
      <Terms xmlns="http://schemas.microsoft.com/office/infopath/2007/PartnerControls"/>
    </lcf76f155ced4ddcb4097134ff3c332f>
    <MigrationWizIdPermissions xmlns="324db12f-297c-40e3-86f6-4d82186512ff" xsi:nil="true"/>
    <MigrationWizId xmlns="324db12f-297c-40e3-86f6-4d82186512ff" xsi:nil="true"/>
    <TaxCatchAll xmlns="28e55284-abd9-4569-8d7b-f719476aa490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8E8871314C8434FB52206FC0D75AEC5" ma:contentTypeVersion="15" ma:contentTypeDescription="Create a new document." ma:contentTypeScope="" ma:versionID="9669befa45aa3885246f648b2dbc40ad">
  <xsd:schema xmlns:xsd="http://www.w3.org/2001/XMLSchema" xmlns:xs="http://www.w3.org/2001/XMLSchema" xmlns:p="http://schemas.microsoft.com/office/2006/metadata/properties" xmlns:ns2="324db12f-297c-40e3-86f6-4d82186512ff" xmlns:ns3="28e55284-abd9-4569-8d7b-f719476aa490" targetNamespace="http://schemas.microsoft.com/office/2006/metadata/properties" ma:root="true" ma:fieldsID="82e65c3b09da1b7f028bd4253ea4a73e" ns2:_="" ns3:_="">
    <xsd:import namespace="324db12f-297c-40e3-86f6-4d82186512ff"/>
    <xsd:import namespace="28e55284-abd9-4569-8d7b-f719476aa490"/>
    <xsd:element name="properties">
      <xsd:complexType>
        <xsd:sequence>
          <xsd:element name="documentManagement">
            <xsd:complexType>
              <xsd:all>
                <xsd:element ref="ns2:MigrationWizId" minOccurs="0"/>
                <xsd:element ref="ns2:MigrationWizIdPermissions" minOccurs="0"/>
                <xsd:element ref="ns2:MigrationWizIdVersion" minOccurs="0"/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4db12f-297c-40e3-86f6-4d82186512ff" elementFormDefault="qualified">
    <xsd:import namespace="http://schemas.microsoft.com/office/2006/documentManagement/types"/>
    <xsd:import namespace="http://schemas.microsoft.com/office/infopath/2007/PartnerControls"/>
    <xsd:element name="MigrationWizId" ma:index="8" nillable="true" ma:displayName="MigrationWizId" ma:internalName="MigrationWizId">
      <xsd:simpleType>
        <xsd:restriction base="dms:Text"/>
      </xsd:simpleType>
    </xsd:element>
    <xsd:element name="MigrationWizIdPermissions" ma:index="9" nillable="true" ma:displayName="MigrationWizIdPermissions" ma:internalName="MigrationWizIdPermissions">
      <xsd:simpleType>
        <xsd:restriction base="dms:Text"/>
      </xsd:simpleType>
    </xsd:element>
    <xsd:element name="MigrationWizIdVersion" ma:index="10" nillable="true" ma:displayName="MigrationWizIdVersion" ma:internalName="MigrationWizIdVersion">
      <xsd:simpleType>
        <xsd:restriction base="dms:Text"/>
      </xsd:simple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ac3562-be2b-463b-9688-fb9859eb15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55284-abd9-4569-8d7b-f719476aa49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652b7d07-4398-489a-9ec2-57654188717d}" ma:internalName="TaxCatchAll" ma:showField="CatchAllData" ma:web="28e55284-abd9-4569-8d7b-f719476aa49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DF37032-7741-4D93-89F5-19AF4A3FBF78}">
  <ds:schemaRefs>
    <ds:schemaRef ds:uri="324db12f-297c-40e3-86f6-4d82186512ff"/>
    <ds:schemaRef ds:uri="28e55284-abd9-4569-8d7b-f719476aa490"/>
    <ds:schemaRef ds:uri="http://purl.org/dc/elements/1.1/"/>
    <ds:schemaRef ds:uri="http://schemas.microsoft.com/office/2006/metadata/properties"/>
    <ds:schemaRef ds:uri="http://purl.org/dc/terms/"/>
    <ds:schemaRef ds:uri="http://schemas.microsoft.com/office/2006/documentManagement/types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9476706C-91E0-4F1C-BC57-D534B9F0486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24db12f-297c-40e3-86f6-4d82186512ff"/>
    <ds:schemaRef ds:uri="28e55284-abd9-4569-8d7b-f719476aa49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73290F3-AE4B-4CC6-8CB8-CC42DF474B4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</TotalTime>
  <Words>169</Words>
  <Application>Microsoft Office PowerPoint</Application>
  <PresentationFormat>A3 Paper (297x420 mm)</PresentationFormat>
  <Paragraphs>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chel Edwards</dc:creator>
  <cp:lastModifiedBy>Rachel Edwards</cp:lastModifiedBy>
  <cp:revision>3</cp:revision>
  <dcterms:created xsi:type="dcterms:W3CDTF">2025-01-17T21:47:54Z</dcterms:created>
  <dcterms:modified xsi:type="dcterms:W3CDTF">2025-12-03T14:39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8E8871314C8434FB52206FC0D75AEC5</vt:lpwstr>
  </property>
  <property fmtid="{D5CDD505-2E9C-101B-9397-08002B2CF9AE}" pid="3" name="MediaServiceImageTags">
    <vt:lpwstr/>
  </property>
</Properties>
</file>